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93" r:id="rId5"/>
    <p:sldId id="294" r:id="rId6"/>
    <p:sldId id="282" r:id="rId7"/>
    <p:sldId id="264" r:id="rId8"/>
    <p:sldId id="291" r:id="rId9"/>
    <p:sldId id="292" r:id="rId10"/>
    <p:sldId id="259" r:id="rId11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DCDCDC"/>
    <a:srgbClr val="FFFFFF"/>
    <a:srgbClr val="00FFFF"/>
    <a:srgbClr val="C8C8C8"/>
    <a:srgbClr val="FFFF00"/>
    <a:srgbClr val="AAAAAA"/>
    <a:srgbClr val="FF00FF"/>
    <a:srgbClr val="C80000"/>
    <a:srgbClr val="E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137" autoAdjust="0"/>
  </p:normalViewPr>
  <p:slideViewPr>
    <p:cSldViewPr snapToGrid="0" snapToObjects="1">
      <p:cViewPr varScale="1">
        <p:scale>
          <a:sx n="125" d="100"/>
          <a:sy n="125" d="100"/>
        </p:scale>
        <p:origin x="108" y="246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8DAD8-82B6-4966-A53E-F640566415A9}" type="datetimeFigureOut">
              <a:rPr lang="en-US" smtClean="0"/>
              <a:pPr/>
              <a:t>11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Flowchart: Or 11"/>
          <p:cNvSpPr/>
          <p:nvPr/>
        </p:nvSpPr>
        <p:spPr>
          <a:xfrm>
            <a:off x="3276600" y="904644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,,</a:t>
            </a:r>
            <a:endParaRPr lang="en-US" dirty="0"/>
          </a:p>
        </p:txBody>
      </p:sp>
      <p:sp>
        <p:nvSpPr>
          <p:cNvPr id="13" name="Flowchart: Or 12"/>
          <p:cNvSpPr/>
          <p:nvPr/>
        </p:nvSpPr>
        <p:spPr>
          <a:xfrm>
            <a:off x="5192751" y="893493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lowchart: Or 13"/>
          <p:cNvSpPr/>
          <p:nvPr/>
        </p:nvSpPr>
        <p:spPr>
          <a:xfrm>
            <a:off x="1380894" y="926946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lowchart: Or 15"/>
          <p:cNvSpPr/>
          <p:nvPr/>
        </p:nvSpPr>
        <p:spPr>
          <a:xfrm>
            <a:off x="1447800" y="3344901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Flowchart: Or 16"/>
          <p:cNvSpPr/>
          <p:nvPr/>
        </p:nvSpPr>
        <p:spPr>
          <a:xfrm>
            <a:off x="3310053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lowchart: Or 17"/>
          <p:cNvSpPr/>
          <p:nvPr/>
        </p:nvSpPr>
        <p:spPr>
          <a:xfrm>
            <a:off x="5203902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lowchart: Or 18"/>
          <p:cNvSpPr/>
          <p:nvPr/>
        </p:nvSpPr>
        <p:spPr>
          <a:xfrm>
            <a:off x="7099608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lowchart: Or 19"/>
          <p:cNvSpPr/>
          <p:nvPr/>
        </p:nvSpPr>
        <p:spPr>
          <a:xfrm>
            <a:off x="7077306" y="893493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20227" y="4774168"/>
            <a:ext cx="5304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ign cages on acrylic stage and move to next slide (↓)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50167" y="1033402"/>
            <a:ext cx="461665" cy="2757548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b="1" dirty="0" smtClean="0"/>
              <a:t>Top of acquired images</a:t>
            </a:r>
            <a:endParaRPr lang="en-US" b="1" dirty="0"/>
          </a:p>
        </p:txBody>
      </p:sp>
      <p:sp>
        <p:nvSpPr>
          <p:cNvPr id="15" name="Heptagon 14"/>
          <p:cNvSpPr/>
          <p:nvPr/>
        </p:nvSpPr>
        <p:spPr>
          <a:xfrm>
            <a:off x="1682513" y="3904780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1018674" y="390416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1676400" y="2518201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Heptagon 22"/>
          <p:cNvSpPr/>
          <p:nvPr/>
        </p:nvSpPr>
        <p:spPr>
          <a:xfrm>
            <a:off x="3552858" y="3896139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2902497" y="3899511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560223" y="2513543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Heptagon 25"/>
          <p:cNvSpPr/>
          <p:nvPr/>
        </p:nvSpPr>
        <p:spPr>
          <a:xfrm>
            <a:off x="5411141" y="3888589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776586" y="390416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5434312" y="2518201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Heptagon 28"/>
          <p:cNvSpPr/>
          <p:nvPr/>
        </p:nvSpPr>
        <p:spPr>
          <a:xfrm>
            <a:off x="7315200" y="3909324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657474" y="390416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7315200" y="2518201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Heptagon 31"/>
          <p:cNvSpPr/>
          <p:nvPr/>
        </p:nvSpPr>
        <p:spPr>
          <a:xfrm>
            <a:off x="1655152" y="217702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1013293" y="7298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1676400" y="2155287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Heptagon 34"/>
          <p:cNvSpPr/>
          <p:nvPr/>
        </p:nvSpPr>
        <p:spPr>
          <a:xfrm>
            <a:off x="3515068" y="210866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2898020" y="7298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3561127" y="2155287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4780547" y="79825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5443654" y="2162123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Heptagon 40"/>
          <p:cNvSpPr/>
          <p:nvPr/>
        </p:nvSpPr>
        <p:spPr>
          <a:xfrm>
            <a:off x="7321510" y="177413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6671339" y="72989"/>
            <a:ext cx="566757" cy="79490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7334446" y="2155287"/>
            <a:ext cx="663546" cy="1069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1618652" y="1847510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3469254" y="1863804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6" name="TextBox 45"/>
          <p:cNvSpPr txBox="1"/>
          <p:nvPr/>
        </p:nvSpPr>
        <p:spPr>
          <a:xfrm>
            <a:off x="5400740" y="1863803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7257452" y="1863802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1579954" y="2601969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3492230" y="2626177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5372970" y="2631917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51" name="TextBox 50"/>
          <p:cNvSpPr txBox="1"/>
          <p:nvPr/>
        </p:nvSpPr>
        <p:spPr>
          <a:xfrm>
            <a:off x="7257452" y="2631917"/>
            <a:ext cx="804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indow</a:t>
            </a:r>
            <a:endParaRPr lang="en-US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1755026" y="409619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3" name="TextBox 52"/>
          <p:cNvSpPr txBox="1"/>
          <p:nvPr/>
        </p:nvSpPr>
        <p:spPr>
          <a:xfrm>
            <a:off x="3595371" y="388645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4" name="TextBox 53"/>
          <p:cNvSpPr txBox="1"/>
          <p:nvPr/>
        </p:nvSpPr>
        <p:spPr>
          <a:xfrm>
            <a:off x="5497088" y="234800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5" name="TextBox 54"/>
          <p:cNvSpPr txBox="1"/>
          <p:nvPr/>
        </p:nvSpPr>
        <p:spPr>
          <a:xfrm>
            <a:off x="7384286" y="355821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6" name="TextBox 55"/>
          <p:cNvSpPr txBox="1"/>
          <p:nvPr/>
        </p:nvSpPr>
        <p:spPr>
          <a:xfrm>
            <a:off x="1726902" y="4083948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7" name="TextBox 56"/>
          <p:cNvSpPr txBox="1"/>
          <p:nvPr/>
        </p:nvSpPr>
        <p:spPr>
          <a:xfrm>
            <a:off x="3640160" y="4077514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5514879" y="4067757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7384286" y="4088492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  <p:sp>
        <p:nvSpPr>
          <p:cNvPr id="60" name="TextBox 59"/>
          <p:cNvSpPr txBox="1"/>
          <p:nvPr/>
        </p:nvSpPr>
        <p:spPr>
          <a:xfrm>
            <a:off x="999724" y="400823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1" name="TextBox 60"/>
          <p:cNvSpPr txBox="1"/>
          <p:nvPr/>
        </p:nvSpPr>
        <p:spPr>
          <a:xfrm>
            <a:off x="2864482" y="385489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2" name="TextBox 61"/>
          <p:cNvSpPr txBox="1"/>
          <p:nvPr/>
        </p:nvSpPr>
        <p:spPr>
          <a:xfrm>
            <a:off x="4767748" y="378840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3" name="TextBox 62"/>
          <p:cNvSpPr txBox="1"/>
          <p:nvPr/>
        </p:nvSpPr>
        <p:spPr>
          <a:xfrm>
            <a:off x="6657474" y="380397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4" name="TextBox 63"/>
          <p:cNvSpPr txBox="1"/>
          <p:nvPr/>
        </p:nvSpPr>
        <p:spPr>
          <a:xfrm>
            <a:off x="995010" y="4077514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5" name="TextBox 64"/>
          <p:cNvSpPr txBox="1"/>
          <p:nvPr/>
        </p:nvSpPr>
        <p:spPr>
          <a:xfrm>
            <a:off x="2874304" y="4077514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6" name="TextBox 65"/>
          <p:cNvSpPr txBox="1"/>
          <p:nvPr/>
        </p:nvSpPr>
        <p:spPr>
          <a:xfrm>
            <a:off x="4732587" y="4089608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7" name="TextBox 66"/>
          <p:cNvSpPr txBox="1"/>
          <p:nvPr/>
        </p:nvSpPr>
        <p:spPr>
          <a:xfrm>
            <a:off x="6636646" y="4089608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ome</a:t>
            </a:r>
            <a:endParaRPr lang="en-US" sz="1400" dirty="0"/>
          </a:p>
        </p:txBody>
      </p:sp>
      <p:sp>
        <p:nvSpPr>
          <p:cNvPr id="68" name="Heptagon 67"/>
          <p:cNvSpPr/>
          <p:nvPr/>
        </p:nvSpPr>
        <p:spPr>
          <a:xfrm>
            <a:off x="5437894" y="216178"/>
            <a:ext cx="689418" cy="657025"/>
          </a:xfrm>
          <a:prstGeom prst="heptagon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68"/>
          <p:cNvSpPr txBox="1"/>
          <p:nvPr/>
        </p:nvSpPr>
        <p:spPr>
          <a:xfrm>
            <a:off x="5504264" y="378840"/>
            <a:ext cx="626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ood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0"/>
            <a:ext cx="8686800" cy="5143500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228600" y="4774168"/>
            <a:ext cx="1859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4 hours day time</a:t>
            </a:r>
            <a:endParaRPr lang="en-US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0"/>
            <a:ext cx="8686800" cy="5143500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8600" y="4774168"/>
            <a:ext cx="1753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 hours day time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 flipV="1">
            <a:off x="438479" y="4579315"/>
            <a:ext cx="248914" cy="45719"/>
          </a:xfrm>
          <a:prstGeom prst="rect">
            <a:avLst/>
          </a:prstGeom>
          <a:noFill/>
          <a:ln>
            <a:solidFill>
              <a:srgbClr val="DCDCD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  <p:transition advClick="0" advTm="21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5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90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 hours night time</a:t>
            </a:r>
            <a:endParaRPr lang="en-US" dirty="0"/>
          </a:p>
        </p:txBody>
      </p:sp>
    </p:spTree>
  </p:cSld>
  <p:clrMapOvr>
    <a:masterClrMapping/>
  </p:clrMapOvr>
  <p:transition advClick="0" advTm="21600000"/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944971" y="1796173"/>
            <a:ext cx="281608" cy="428393"/>
            <a:chOff x="2002210" y="1855172"/>
            <a:chExt cx="318742" cy="484883"/>
          </a:xfrm>
        </p:grpSpPr>
        <p:sp>
          <p:nvSpPr>
            <p:cNvPr id="12" name="Oval 11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7" name="Oval 36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8" name="Oval 37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9" name="Oval 38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0" name="Oval 39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41" name="Straight Connector 40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Freeform 7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3" name="Freeform 42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/>
          <p:cNvGrpSpPr/>
          <p:nvPr/>
        </p:nvGrpSpPr>
        <p:grpSpPr>
          <a:xfrm>
            <a:off x="1071837" y="1789851"/>
            <a:ext cx="281608" cy="428393"/>
            <a:chOff x="2002210" y="1855172"/>
            <a:chExt cx="318742" cy="484883"/>
          </a:xfrm>
        </p:grpSpPr>
        <p:sp>
          <p:nvSpPr>
            <p:cNvPr id="36" name="Oval 35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5" name="Oval 44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8" name="Oval 47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0" name="Oval 49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1" name="Oval 50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52" name="Straight Connector 51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Freeform 53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5" name="Freeform 54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56" name="Straight Connector 55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/>
          <p:cNvGrpSpPr/>
          <p:nvPr/>
        </p:nvGrpSpPr>
        <p:grpSpPr>
          <a:xfrm>
            <a:off x="2941693" y="2563860"/>
            <a:ext cx="281608" cy="428393"/>
            <a:chOff x="2002210" y="1855172"/>
            <a:chExt cx="318742" cy="484883"/>
          </a:xfrm>
        </p:grpSpPr>
        <p:sp>
          <p:nvSpPr>
            <p:cNvPr id="59" name="Oval 58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0" name="Oval 59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1" name="Oval 60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2" name="Oval 61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3" name="Oval 62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Freeform 65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7" name="Freeform 66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oup 69"/>
          <p:cNvGrpSpPr/>
          <p:nvPr/>
        </p:nvGrpSpPr>
        <p:grpSpPr>
          <a:xfrm>
            <a:off x="1062588" y="2577564"/>
            <a:ext cx="281608" cy="428393"/>
            <a:chOff x="2002210" y="1855172"/>
            <a:chExt cx="318742" cy="484883"/>
          </a:xfrm>
        </p:grpSpPr>
        <p:sp>
          <p:nvSpPr>
            <p:cNvPr id="71" name="Oval 70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2" name="Oval 71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3" name="Oval 72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4" name="Oval 73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5" name="Oval 74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76" name="Straight Connector 75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Freeform 77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9" name="Freeform 78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80" name="Straight Connector 79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oup 87"/>
          <p:cNvGrpSpPr/>
          <p:nvPr/>
        </p:nvGrpSpPr>
        <p:grpSpPr>
          <a:xfrm>
            <a:off x="6736393" y="1802794"/>
            <a:ext cx="281608" cy="428393"/>
            <a:chOff x="2002210" y="1855172"/>
            <a:chExt cx="318742" cy="484883"/>
          </a:xfrm>
        </p:grpSpPr>
        <p:sp>
          <p:nvSpPr>
            <p:cNvPr id="89" name="Oval 88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0" name="Oval 89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1" name="Oval 90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2" name="Oval 91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3" name="Oval 92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94" name="Straight Connector 93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Freeform 95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7" name="Freeform 96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98" name="Straight Connector 97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oup 99"/>
          <p:cNvGrpSpPr/>
          <p:nvPr/>
        </p:nvGrpSpPr>
        <p:grpSpPr>
          <a:xfrm>
            <a:off x="4863259" y="1796472"/>
            <a:ext cx="281608" cy="428393"/>
            <a:chOff x="2002210" y="1855172"/>
            <a:chExt cx="318742" cy="484883"/>
          </a:xfrm>
        </p:grpSpPr>
        <p:sp>
          <p:nvSpPr>
            <p:cNvPr id="101" name="Oval 100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2" name="Oval 101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3" name="Oval 102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4" name="Oval 103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5" name="Oval 104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06" name="Straight Connector 105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Freeform 107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9" name="Freeform 108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Group 111"/>
          <p:cNvGrpSpPr/>
          <p:nvPr/>
        </p:nvGrpSpPr>
        <p:grpSpPr>
          <a:xfrm>
            <a:off x="6733115" y="2570481"/>
            <a:ext cx="281608" cy="428393"/>
            <a:chOff x="2002210" y="1855172"/>
            <a:chExt cx="318742" cy="484883"/>
          </a:xfrm>
        </p:grpSpPr>
        <p:sp>
          <p:nvSpPr>
            <p:cNvPr id="113" name="Oval 112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4" name="Oval 113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5" name="Oval 114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6" name="Oval 115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7" name="Oval 116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18" name="Straight Connector 117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Freeform 119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1" name="Freeform 120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22" name="Straight Connector 121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Group 123"/>
          <p:cNvGrpSpPr/>
          <p:nvPr/>
        </p:nvGrpSpPr>
        <p:grpSpPr>
          <a:xfrm>
            <a:off x="4854010" y="2584185"/>
            <a:ext cx="281608" cy="428393"/>
            <a:chOff x="2002210" y="1855172"/>
            <a:chExt cx="318742" cy="484883"/>
          </a:xfrm>
        </p:grpSpPr>
        <p:sp>
          <p:nvSpPr>
            <p:cNvPr id="125" name="Oval 124"/>
            <p:cNvSpPr/>
            <p:nvPr/>
          </p:nvSpPr>
          <p:spPr>
            <a:xfrm>
              <a:off x="2136539" y="2058533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6" name="Oval 125"/>
            <p:cNvSpPr/>
            <p:nvPr/>
          </p:nvSpPr>
          <p:spPr>
            <a:xfrm>
              <a:off x="2193464" y="2060898"/>
              <a:ext cx="79315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7" name="Oval 126"/>
            <p:cNvSpPr/>
            <p:nvPr/>
          </p:nvSpPr>
          <p:spPr>
            <a:xfrm>
              <a:off x="2015412" y="2060898"/>
              <a:ext cx="182508" cy="79315"/>
            </a:xfrm>
            <a:prstGeom prst="ellips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8" name="Oval 127"/>
            <p:cNvSpPr/>
            <p:nvPr/>
          </p:nvSpPr>
          <p:spPr>
            <a:xfrm>
              <a:off x="2222008" y="2060898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9" name="Oval 128"/>
            <p:cNvSpPr/>
            <p:nvPr/>
          </p:nvSpPr>
          <p:spPr>
            <a:xfrm>
              <a:off x="2222008" y="2101376"/>
              <a:ext cx="39657" cy="3965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30" name="Straight Connector 129"/>
            <p:cNvCxnSpPr/>
            <p:nvPr/>
          </p:nvCxnSpPr>
          <p:spPr>
            <a:xfrm flipH="1">
              <a:off x="2264377" y="2078300"/>
              <a:ext cx="44317" cy="12165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 flipH="1" flipV="1">
              <a:off x="2258338" y="2096656"/>
              <a:ext cx="44317" cy="25201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Freeform 131"/>
            <p:cNvSpPr/>
            <p:nvPr/>
          </p:nvSpPr>
          <p:spPr>
            <a:xfrm>
              <a:off x="2004122" y="1855172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3" name="Freeform 132"/>
            <p:cNvSpPr/>
            <p:nvPr/>
          </p:nvSpPr>
          <p:spPr>
            <a:xfrm flipV="1">
              <a:off x="2002210" y="2118110"/>
              <a:ext cx="268657" cy="221945"/>
            </a:xfrm>
            <a:custGeom>
              <a:avLst/>
              <a:gdLst>
                <a:gd name="connsiteX0" fmla="*/ 60402 w 281382"/>
                <a:gd name="connsiteY0" fmla="*/ 214335 h 229575"/>
                <a:gd name="connsiteX1" fmla="*/ 1347 w 281382"/>
                <a:gd name="connsiteY1" fmla="*/ 61935 h 229575"/>
                <a:gd name="connsiteX2" fmla="*/ 111837 w 281382"/>
                <a:gd name="connsiteY2" fmla="*/ 18120 h 229575"/>
                <a:gd name="connsiteX3" fmla="*/ 140412 w 281382"/>
                <a:gd name="connsiteY3" fmla="*/ 153375 h 229575"/>
                <a:gd name="connsiteX4" fmla="*/ 153747 w 281382"/>
                <a:gd name="connsiteY4" fmla="*/ 4785 h 229575"/>
                <a:gd name="connsiteX5" fmla="*/ 281382 w 281382"/>
                <a:gd name="connsiteY5" fmla="*/ 54315 h 229575"/>
                <a:gd name="connsiteX6" fmla="*/ 153747 w 281382"/>
                <a:gd name="connsiteY6" fmla="*/ 229575 h 229575"/>
                <a:gd name="connsiteX0" fmla="*/ 100993 w 280063"/>
                <a:gd name="connsiteY0" fmla="*/ 233385 h 233385"/>
                <a:gd name="connsiteX1" fmla="*/ 28 w 280063"/>
                <a:gd name="connsiteY1" fmla="*/ 61935 h 233385"/>
                <a:gd name="connsiteX2" fmla="*/ 110518 w 280063"/>
                <a:gd name="connsiteY2" fmla="*/ 18120 h 233385"/>
                <a:gd name="connsiteX3" fmla="*/ 139093 w 280063"/>
                <a:gd name="connsiteY3" fmla="*/ 153375 h 233385"/>
                <a:gd name="connsiteX4" fmla="*/ 152428 w 280063"/>
                <a:gd name="connsiteY4" fmla="*/ 4785 h 233385"/>
                <a:gd name="connsiteX5" fmla="*/ 280063 w 280063"/>
                <a:gd name="connsiteY5" fmla="*/ 54315 h 233385"/>
                <a:gd name="connsiteX6" fmla="*/ 152428 w 280063"/>
                <a:gd name="connsiteY6" fmla="*/ 229575 h 233385"/>
                <a:gd name="connsiteX0" fmla="*/ 101031 w 280101"/>
                <a:gd name="connsiteY0" fmla="*/ 233385 h 233385"/>
                <a:gd name="connsiteX1" fmla="*/ 66 w 280101"/>
                <a:gd name="connsiteY1" fmla="*/ 61935 h 233385"/>
                <a:gd name="connsiteX2" fmla="*/ 110556 w 280101"/>
                <a:gd name="connsiteY2" fmla="*/ 18120 h 233385"/>
                <a:gd name="connsiteX3" fmla="*/ 139131 w 280101"/>
                <a:gd name="connsiteY3" fmla="*/ 153375 h 233385"/>
                <a:gd name="connsiteX4" fmla="*/ 152466 w 280101"/>
                <a:gd name="connsiteY4" fmla="*/ 4785 h 233385"/>
                <a:gd name="connsiteX5" fmla="*/ 280101 w 280101"/>
                <a:gd name="connsiteY5" fmla="*/ 54315 h 233385"/>
                <a:gd name="connsiteX6" fmla="*/ 152466 w 280101"/>
                <a:gd name="connsiteY6" fmla="*/ 229575 h 233385"/>
                <a:gd name="connsiteX0" fmla="*/ 101031 w 280101"/>
                <a:gd name="connsiteY0" fmla="*/ 235249 h 235249"/>
                <a:gd name="connsiteX1" fmla="*/ 66 w 280101"/>
                <a:gd name="connsiteY1" fmla="*/ 63799 h 235249"/>
                <a:gd name="connsiteX2" fmla="*/ 110556 w 280101"/>
                <a:gd name="connsiteY2" fmla="*/ 19984 h 235249"/>
                <a:gd name="connsiteX3" fmla="*/ 127701 w 280101"/>
                <a:gd name="connsiteY3" fmla="*/ 183814 h 235249"/>
                <a:gd name="connsiteX4" fmla="*/ 152466 w 280101"/>
                <a:gd name="connsiteY4" fmla="*/ 6649 h 235249"/>
                <a:gd name="connsiteX5" fmla="*/ 280101 w 280101"/>
                <a:gd name="connsiteY5" fmla="*/ 56179 h 235249"/>
                <a:gd name="connsiteX6" fmla="*/ 152466 w 280101"/>
                <a:gd name="connsiteY6" fmla="*/ 231439 h 235249"/>
                <a:gd name="connsiteX0" fmla="*/ 129573 w 308643"/>
                <a:gd name="connsiteY0" fmla="*/ 235249 h 235249"/>
                <a:gd name="connsiteX1" fmla="*/ 33 w 308643"/>
                <a:gd name="connsiteY1" fmla="*/ 63799 h 235249"/>
                <a:gd name="connsiteX2" fmla="*/ 139098 w 308643"/>
                <a:gd name="connsiteY2" fmla="*/ 19984 h 235249"/>
                <a:gd name="connsiteX3" fmla="*/ 156243 w 308643"/>
                <a:gd name="connsiteY3" fmla="*/ 183814 h 235249"/>
                <a:gd name="connsiteX4" fmla="*/ 181008 w 308643"/>
                <a:gd name="connsiteY4" fmla="*/ 6649 h 235249"/>
                <a:gd name="connsiteX5" fmla="*/ 308643 w 308643"/>
                <a:gd name="connsiteY5" fmla="*/ 56179 h 235249"/>
                <a:gd name="connsiteX6" fmla="*/ 181008 w 308643"/>
                <a:gd name="connsiteY6" fmla="*/ 231439 h 235249"/>
                <a:gd name="connsiteX0" fmla="*/ 129573 w 308655"/>
                <a:gd name="connsiteY0" fmla="*/ 221945 h 221945"/>
                <a:gd name="connsiteX1" fmla="*/ 33 w 308655"/>
                <a:gd name="connsiteY1" fmla="*/ 50495 h 221945"/>
                <a:gd name="connsiteX2" fmla="*/ 139098 w 308655"/>
                <a:gd name="connsiteY2" fmla="*/ 6680 h 221945"/>
                <a:gd name="connsiteX3" fmla="*/ 156243 w 308655"/>
                <a:gd name="connsiteY3" fmla="*/ 170510 h 221945"/>
                <a:gd name="connsiteX4" fmla="*/ 188628 w 308655"/>
                <a:gd name="connsiteY4" fmla="*/ 33350 h 221945"/>
                <a:gd name="connsiteX5" fmla="*/ 308643 w 308655"/>
                <a:gd name="connsiteY5" fmla="*/ 42875 h 221945"/>
                <a:gd name="connsiteX6" fmla="*/ 181008 w 308655"/>
                <a:gd name="connsiteY6" fmla="*/ 218135 h 221945"/>
                <a:gd name="connsiteX0" fmla="*/ 129573 w 268657"/>
                <a:gd name="connsiteY0" fmla="*/ 221945 h 221945"/>
                <a:gd name="connsiteX1" fmla="*/ 33 w 268657"/>
                <a:gd name="connsiteY1" fmla="*/ 50495 h 221945"/>
                <a:gd name="connsiteX2" fmla="*/ 139098 w 268657"/>
                <a:gd name="connsiteY2" fmla="*/ 6680 h 221945"/>
                <a:gd name="connsiteX3" fmla="*/ 156243 w 268657"/>
                <a:gd name="connsiteY3" fmla="*/ 170510 h 221945"/>
                <a:gd name="connsiteX4" fmla="*/ 188628 w 268657"/>
                <a:gd name="connsiteY4" fmla="*/ 33350 h 221945"/>
                <a:gd name="connsiteX5" fmla="*/ 268638 w 268657"/>
                <a:gd name="connsiteY5" fmla="*/ 63830 h 221945"/>
                <a:gd name="connsiteX6" fmla="*/ 181008 w 268657"/>
                <a:gd name="connsiteY6" fmla="*/ 218135 h 2219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68657" h="221945">
                  <a:moveTo>
                    <a:pt x="129573" y="221945"/>
                  </a:moveTo>
                  <a:cubicBezTo>
                    <a:pt x="53849" y="139236"/>
                    <a:pt x="-1554" y="86372"/>
                    <a:pt x="33" y="50495"/>
                  </a:cubicBezTo>
                  <a:cubicBezTo>
                    <a:pt x="1620" y="14618"/>
                    <a:pt x="113063" y="-13322"/>
                    <a:pt x="139098" y="6680"/>
                  </a:cubicBezTo>
                  <a:cubicBezTo>
                    <a:pt x="165133" y="26682"/>
                    <a:pt x="147988" y="166065"/>
                    <a:pt x="156243" y="170510"/>
                  </a:cubicBezTo>
                  <a:cubicBezTo>
                    <a:pt x="164498" y="174955"/>
                    <a:pt x="169896" y="51130"/>
                    <a:pt x="188628" y="33350"/>
                  </a:cubicBezTo>
                  <a:cubicBezTo>
                    <a:pt x="207361" y="15570"/>
                    <a:pt x="269908" y="33033"/>
                    <a:pt x="268638" y="63830"/>
                  </a:cubicBezTo>
                  <a:cubicBezTo>
                    <a:pt x="267368" y="94627"/>
                    <a:pt x="244825" y="149237"/>
                    <a:pt x="181008" y="218135"/>
                  </a:cubicBezTo>
                </a:path>
              </a:pathLst>
            </a:cu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cxnSp>
          <p:nvCxnSpPr>
            <p:cNvPr id="134" name="Straight Connector 133"/>
            <p:cNvCxnSpPr/>
            <p:nvPr/>
          </p:nvCxnSpPr>
          <p:spPr>
            <a:xfrm flipH="1">
              <a:off x="2304561" y="2028828"/>
              <a:ext cx="16391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>
              <a:off x="2299418" y="2119529"/>
              <a:ext cx="18562" cy="50627"/>
            </a:xfrm>
            <a:prstGeom prst="line">
              <a:avLst/>
            </a:prstGeom>
            <a:ln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8" name="TextBox 147"/>
          <p:cNvSpPr txBox="1"/>
          <p:nvPr/>
        </p:nvSpPr>
        <p:spPr>
          <a:xfrm>
            <a:off x="228600" y="4774168"/>
            <a:ext cx="2019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 yellow moth</a:t>
            </a:r>
            <a:endParaRPr lang="en-US" dirty="0"/>
          </a:p>
        </p:txBody>
      </p:sp>
      <p:sp>
        <p:nvSpPr>
          <p:cNvPr id="136" name="Rectangle 135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7" name="Rectangle 136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8" name="Rectangle 137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9" name="Rectangle 138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0" name="Rectangle 139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1" name="Rectangle 140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2" name="Rectangle 141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3" name="Rectangle 142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352428334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3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8" dur="2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0" dur="2000" fill="hold"/>
                                        <p:tgtEl>
                                          <p:spTgt spid="10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2" dur="20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4" dur="2000" fill="hold"/>
                                        <p:tgtEl>
                                          <p:spTgt spid="7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6" dur="20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8" dur="2000" fill="hold"/>
                                        <p:tgtEl>
                                          <p:spTgt spid="1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" dur="2000" fill="hold"/>
                                        <p:tgtEl>
                                          <p:spTgt spid="1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 hour night tim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7856888"/>
      </p:ext>
    </p:extLst>
  </p:cSld>
  <p:clrMapOvr>
    <a:masterClrMapping/>
  </p:clrMapOvr>
  <p:transition advClick="0" advTm="3600000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914401" y="1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787804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92803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577360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925552" y="3560618"/>
            <a:ext cx="7478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2787803" y="3560618"/>
            <a:ext cx="758953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681654" y="3560618"/>
            <a:ext cx="7701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6566209" y="3560618"/>
            <a:ext cx="770104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228600" y="4774168"/>
            <a:ext cx="3562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 home light with moving lines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-87780" y="0"/>
            <a:ext cx="9326880" cy="914400"/>
            <a:chOff x="0" y="0"/>
            <a:chExt cx="9326880" cy="914400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0" y="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0" y="4572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0" y="9144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-95095" y="3879312"/>
            <a:ext cx="9330528" cy="914400"/>
            <a:chOff x="0" y="3861206"/>
            <a:chExt cx="9330528" cy="914400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3648" y="38612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215" y="43184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0" y="47756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Rectangle 22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293741645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77778E-6 1.11111E-6 L -0.00018 0.08889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7" y="4444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1.23457E-7 L 0.00034 -0.08889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7" y="-444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 hour night time</a:t>
            </a:r>
            <a:endParaRPr lang="en-US" dirty="0"/>
          </a:p>
        </p:txBody>
      </p:sp>
    </p:spTree>
  </p:cSld>
  <p:clrMapOvr>
    <a:masterClrMapping/>
  </p:clrMapOvr>
  <p:transition advClick="0" advTm="3600000"/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914401" y="1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787804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92803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577360" y="0"/>
            <a:ext cx="758952" cy="1131376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925552" y="3560618"/>
            <a:ext cx="7478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2787803" y="3560618"/>
            <a:ext cx="758953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4681654" y="3560618"/>
            <a:ext cx="770102" cy="1214507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6566209" y="3560618"/>
            <a:ext cx="770104" cy="1220932"/>
          </a:xfrm>
          <a:prstGeom prst="rect">
            <a:avLst/>
          </a:prstGeom>
          <a:solidFill>
            <a:srgbClr val="C8C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228600" y="4774168"/>
            <a:ext cx="3562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 hour home light with moving lines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-87780" y="0"/>
            <a:ext cx="9326880" cy="914400"/>
            <a:chOff x="0" y="0"/>
            <a:chExt cx="9326880" cy="914400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0" y="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0" y="4572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0" y="914400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-95095" y="3879312"/>
            <a:ext cx="9330528" cy="914400"/>
            <a:chOff x="0" y="3861206"/>
            <a:chExt cx="9330528" cy="914400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3648" y="38612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215" y="43184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0" y="4775606"/>
              <a:ext cx="9326880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Rectangle 22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393673203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77778E-6 1.11111E-6 L -0.00018 0.08889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7" y="4444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61111E-6 1.23457E-7 L 0.00034 -0.08889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7" y="-444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4774168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 hour night tim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7523419"/>
      </p:ext>
    </p:extLst>
  </p:cSld>
  <p:clrMapOvr>
    <a:masterClrMapping/>
  </p:clrMapOvr>
  <p:transition advClick="0" advTm="3600000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98</TotalTime>
  <Words>86</Words>
  <Application>Microsoft Office PowerPoint</Application>
  <PresentationFormat>On-screen Show (16:9)</PresentationFormat>
  <Paragraphs>3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ow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Creton, Robbert</cp:lastModifiedBy>
  <cp:revision>116</cp:revision>
  <dcterms:created xsi:type="dcterms:W3CDTF">2022-09-30T15:38:18Z</dcterms:created>
  <dcterms:modified xsi:type="dcterms:W3CDTF">2022-11-10T14:15:14Z</dcterms:modified>
</cp:coreProperties>
</file>